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png" ContentType="image/png"/>
  <Default Extension="rels" ContentType="application/vnd.openxmlformats-package.relationships+xml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 varScale="1">
        <p:scale>
          <a:sx n="145" d="100"/>
          <a:sy n="145" d="100"/>
        </p:scale>
        <p:origin x="72" y="4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BEEE9-9B1B-4EFA-BCF9-94F5064D3408}" type="datetimeFigureOut">
              <a:rPr lang="en-US" smtClean="0"/>
              <a:t>7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CADBF-3A50-4CB6-BB69-65FD1DCDA1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8100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BEEE9-9B1B-4EFA-BCF9-94F5064D3408}" type="datetimeFigureOut">
              <a:rPr lang="en-US" smtClean="0"/>
              <a:t>7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CADBF-3A50-4CB6-BB69-65FD1DCDA1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81059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BEEE9-9B1B-4EFA-BCF9-94F5064D3408}" type="datetimeFigureOut">
              <a:rPr lang="en-US" smtClean="0"/>
              <a:t>7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CADBF-3A50-4CB6-BB69-65FD1DCDA1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47099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BEEE9-9B1B-4EFA-BCF9-94F5064D3408}" type="datetimeFigureOut">
              <a:rPr lang="en-US" smtClean="0"/>
              <a:t>7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CADBF-3A50-4CB6-BB69-65FD1DCDA1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20802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BEEE9-9B1B-4EFA-BCF9-94F5064D3408}" type="datetimeFigureOut">
              <a:rPr lang="en-US" smtClean="0"/>
              <a:t>7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CADBF-3A50-4CB6-BB69-65FD1DCDA1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93819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BEEE9-9B1B-4EFA-BCF9-94F5064D3408}" type="datetimeFigureOut">
              <a:rPr lang="en-US" smtClean="0"/>
              <a:t>7/1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CADBF-3A50-4CB6-BB69-65FD1DCDA1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64553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BEEE9-9B1B-4EFA-BCF9-94F5064D3408}" type="datetimeFigureOut">
              <a:rPr lang="en-US" smtClean="0"/>
              <a:t>7/17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CADBF-3A50-4CB6-BB69-65FD1DCDA1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27277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BEEE9-9B1B-4EFA-BCF9-94F5064D3408}" type="datetimeFigureOut">
              <a:rPr lang="en-US" smtClean="0"/>
              <a:t>7/17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CADBF-3A50-4CB6-BB69-65FD1DCDA1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10998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BEEE9-9B1B-4EFA-BCF9-94F5064D3408}" type="datetimeFigureOut">
              <a:rPr lang="en-US" smtClean="0"/>
              <a:t>7/17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CADBF-3A50-4CB6-BB69-65FD1DCDA1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88849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BEEE9-9B1B-4EFA-BCF9-94F5064D3408}" type="datetimeFigureOut">
              <a:rPr lang="en-US" smtClean="0"/>
              <a:t>7/1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CADBF-3A50-4CB6-BB69-65FD1DCDA1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28784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BEEE9-9B1B-4EFA-BCF9-94F5064D3408}" type="datetimeFigureOut">
              <a:rPr lang="en-US" smtClean="0"/>
              <a:t>7/1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CADBF-3A50-4CB6-BB69-65FD1DCDA1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42757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2BEEE9-9B1B-4EFA-BCF9-94F5064D3408}" type="datetimeFigureOut">
              <a:rPr lang="en-US" smtClean="0"/>
              <a:t>7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7CADBF-3A50-4CB6-BB69-65FD1DCDA1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64644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w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AEEA4696-B743-4942-B8C8-336AF31EF42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84010646"/>
              </p:ext>
            </p:extLst>
          </p:nvPr>
        </p:nvGraphicFramePr>
        <p:xfrm>
          <a:off x="5778500" y="155575"/>
          <a:ext cx="3444875" cy="1009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ackager Shell Object" showAsIcon="1" r:id="rId2" imgW="1644480" imgH="482760" progId="Package">
                  <p:embed/>
                </p:oleObj>
              </mc:Choice>
              <mc:Fallback>
                <p:oleObj name="Packager Shell Object" showAsIcon="1" r:id="rId2" imgW="1644480" imgH="482760" progId="Package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778500" y="155575"/>
                        <a:ext cx="3444875" cy="10096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F6BE3BF5-740C-6E60-507E-E5B44B46A013}"/>
              </a:ext>
            </a:extLst>
          </p:cNvPr>
          <p:cNvSpPr txBox="1"/>
          <p:nvPr/>
        </p:nvSpPr>
        <p:spPr>
          <a:xfrm>
            <a:off x="6507011" y="1609309"/>
            <a:ext cx="2156187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Double click the icon for 3D rotation of the model by mouse in your default browser  </a:t>
            </a:r>
          </a:p>
        </p:txBody>
      </p:sp>
      <p:sp>
        <p:nvSpPr>
          <p:cNvPr id="3" name="Arrow: Down 2">
            <a:extLst>
              <a:ext uri="{FF2B5EF4-FFF2-40B4-BE49-F238E27FC236}">
                <a16:creationId xmlns:a16="http://schemas.microsoft.com/office/drawing/2014/main" id="{E35BFC81-2761-E7BB-3229-12E69EE06E20}"/>
              </a:ext>
            </a:extLst>
          </p:cNvPr>
          <p:cNvSpPr/>
          <p:nvPr/>
        </p:nvSpPr>
        <p:spPr>
          <a:xfrm flipV="1">
            <a:off x="7415120" y="1163833"/>
            <a:ext cx="169985" cy="445476"/>
          </a:xfrm>
          <a:prstGeom prst="down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A4F6F27-A10C-91E1-16C9-7AE08E5BD020}"/>
              </a:ext>
            </a:extLst>
          </p:cNvPr>
          <p:cNvSpPr txBox="1"/>
          <p:nvPr/>
        </p:nvSpPr>
        <p:spPr>
          <a:xfrm>
            <a:off x="631723" y="5837287"/>
            <a:ext cx="8141677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S1.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urther spatial details of our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model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hown in Fig. 1B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of the main text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By double-clicking the icon in right-top corner, the model can be explored interactively in a 3D viewer in a default web browser (Google Chrome, Firefox, MS Edge). The model consists of two loosely coupled clusters (modules) of tightly coupled cells: 242 cells in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SAN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module (red circles) and 243 cells in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SAN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module (blue circles). 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81AB6E41-32F8-D41B-6F2E-6E1076E7743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636" t="2131" r="4141" b="1884"/>
          <a:stretch/>
        </p:blipFill>
        <p:spPr>
          <a:xfrm>
            <a:off x="1356360" y="132312"/>
            <a:ext cx="4370675" cy="5775222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CFDAEE74-AB37-3309-B7B5-0BA69F75470D}"/>
              </a:ext>
            </a:extLst>
          </p:cNvPr>
          <p:cNvSpPr txBox="1"/>
          <p:nvPr/>
        </p:nvSpPr>
        <p:spPr>
          <a:xfrm>
            <a:off x="2200422" y="605214"/>
            <a:ext cx="768956" cy="4046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sSAN</a:t>
            </a:r>
            <a:endParaRPr 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B337CB0-79CF-B21A-1DFC-3CBBE685B338}"/>
              </a:ext>
            </a:extLst>
          </p:cNvPr>
          <p:cNvSpPr txBox="1"/>
          <p:nvPr/>
        </p:nvSpPr>
        <p:spPr>
          <a:xfrm>
            <a:off x="4702562" y="5236527"/>
            <a:ext cx="726046" cy="4046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iSAN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446408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resentation1" id="{85681A15-4759-460B-8812-EDAABCF1C3F9}" vid="{52AD63C0-794A-45BE-B74C-DA043E10E0C7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1217</TotalTime>
  <Words>105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ackag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ltsev, Victor (NIH/NIA/IRP) [E]</dc:creator>
  <cp:lastModifiedBy>Maltsev, Victor (NIH/NIA/IRP) [E]</cp:lastModifiedBy>
  <cp:revision>11</cp:revision>
  <dcterms:created xsi:type="dcterms:W3CDTF">2023-07-15T20:49:27Z</dcterms:created>
  <dcterms:modified xsi:type="dcterms:W3CDTF">2023-07-17T16:24:31Z</dcterms:modified>
</cp:coreProperties>
</file>